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7150100" cy="94503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4F7D9D-BAAF-4245-AABE-1F4BB8C0922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7FF1A7-42A8-4F87-AB93-40021320CC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97DC5C-1F65-4D7B-99E6-5553EF469D0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B86969-D8A9-494B-8461-9CE127E9570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9E32BF-0B5C-4219-BAE9-77B8B5B83E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277BDD-F653-49E0-928B-34DA0DC20D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861B8E-555F-4041-AA6B-788A04989B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47287B-C31D-42AA-A0F8-593BEA7CF9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A3A8E6-48FD-487E-8472-A5FD14305F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48BD7E-97E9-451C-ACF3-A0A01E7F4D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E8BA90-EBBF-4DF9-B932-86FD54AE4A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BDBF88-9345-4DED-9A3E-C932F6D8BD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BE2E3B-D0AE-40AF-9F18-E31C07BB44D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2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525680" y="457200"/>
            <a:ext cx="60418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Create PSCP File from Internal Databas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446040" y="1343160"/>
          <a:ext cx="8390160" cy="4470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46040" y="1343160"/>
                    <a:ext cx="8390160" cy="4470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482760" y="768240"/>
            <a:ext cx="8118360" cy="608976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1316880" y="171360"/>
            <a:ext cx="6497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FXR and LXR Regulation of Cholesterol Metabolism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301680" y="484200"/>
            <a:ext cx="8497800" cy="637380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1316880" y="171360"/>
            <a:ext cx="6497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FXR and LXR Regulation of Cholesterol Metabolism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" name=""/>
          <p:cNvGrpSpPr/>
          <p:nvPr/>
        </p:nvGrpSpPr>
        <p:grpSpPr>
          <a:xfrm>
            <a:off x="2219400" y="1022400"/>
            <a:ext cx="1295280" cy="2814480"/>
            <a:chOff x="2219400" y="1022400"/>
            <a:chExt cx="1295280" cy="2814480"/>
          </a:xfrm>
        </p:grpSpPr>
        <p:sp>
          <p:nvSpPr>
            <p:cNvPr id="49" name=""/>
            <p:cNvSpPr/>
            <p:nvPr/>
          </p:nvSpPr>
          <p:spPr>
            <a:xfrm>
              <a:off x="2219400" y="1022400"/>
              <a:ext cx="255600" cy="120600"/>
            </a:xfrm>
            <a:prstGeom prst="rect">
              <a:avLst/>
            </a:prstGeom>
            <a:noFill/>
            <a:ln w="38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259080" y="3716280"/>
              <a:ext cx="255600" cy="120600"/>
            </a:xfrm>
            <a:prstGeom prst="rect">
              <a:avLst/>
            </a:prstGeom>
            <a:noFill/>
            <a:ln w="38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1" name=""/>
          <p:cNvGraphicFramePr/>
          <p:nvPr/>
        </p:nvGraphicFramePr>
        <p:xfrm>
          <a:off x="228600" y="304920"/>
          <a:ext cx="8915400" cy="63450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28600" y="304920"/>
                    <a:ext cx="8915400" cy="6345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4-18T03:50:59Z</dcterms:created>
  <dc:creator>Ming Yi</dc:creator>
  <dc:description/>
  <dc:language>en-US</dc:language>
  <cp:lastModifiedBy>MingYi</cp:lastModifiedBy>
  <dcterms:modified xsi:type="dcterms:W3CDTF">2005-11-08T22:42:03Z</dcterms:modified>
  <cp:revision>11</cp:revision>
  <dc:subject/>
  <dc:title>Slide 1</dc:title>
</cp:coreProperties>
</file>